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0" r:id="rId3"/>
  </p:sldIdLst>
  <p:sldSz cx="6858000" cy="9906000" type="A4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B5B5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160" autoAdjust="0"/>
    <p:restoredTop sz="94660"/>
  </p:normalViewPr>
  <p:slideViewPr>
    <p:cSldViewPr snapToGrid="0" showGuides="1">
      <p:cViewPr>
        <p:scale>
          <a:sx n="75" d="100"/>
          <a:sy n="75" d="100"/>
        </p:scale>
        <p:origin x="1888" y="3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ão Pinto" userId="3983c4a5-bc8e-4389-9adc-46e9aa6992e1" providerId="ADAL" clId="{B27FF475-8F70-4EF2-8386-B74BEE219E59}"/>
    <pc:docChg chg="delSld">
      <pc:chgData name="João Pinto" userId="3983c4a5-bc8e-4389-9adc-46e9aa6992e1" providerId="ADAL" clId="{B27FF475-8F70-4EF2-8386-B74BEE219E59}" dt="2024-12-09T17:01:48.317" v="0" actId="47"/>
      <pc:docMkLst>
        <pc:docMk/>
      </pc:docMkLst>
      <pc:sldChg chg="del">
        <pc:chgData name="João Pinto" userId="3983c4a5-bc8e-4389-9adc-46e9aa6992e1" providerId="ADAL" clId="{B27FF475-8F70-4EF2-8386-B74BEE219E59}" dt="2024-12-09T17:01:48.317" v="0" actId="47"/>
        <pc:sldMkLst>
          <pc:docMk/>
          <pc:sldMk cId="3701817889" sldId="258"/>
        </pc:sldMkLst>
      </pc:sldChg>
      <pc:sldChg chg="del">
        <pc:chgData name="João Pinto" userId="3983c4a5-bc8e-4389-9adc-46e9aa6992e1" providerId="ADAL" clId="{B27FF475-8F70-4EF2-8386-B74BEE219E59}" dt="2024-12-09T17:01:48.317" v="0" actId="47"/>
        <pc:sldMkLst>
          <pc:docMk/>
          <pc:sldMk cId="1785144122" sldId="259"/>
        </pc:sldMkLst>
      </pc:sldChg>
      <pc:sldChg chg="del">
        <pc:chgData name="João Pinto" userId="3983c4a5-bc8e-4389-9adc-46e9aa6992e1" providerId="ADAL" clId="{B27FF475-8F70-4EF2-8386-B74BEE219E59}" dt="2024-12-09T17:01:48.317" v="0" actId="47"/>
        <pc:sldMkLst>
          <pc:docMk/>
          <pc:sldMk cId="3920774359" sldId="261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1721D8-7537-4217-957A-78F7EF9BAA1D}" type="datetimeFigureOut">
              <a:rPr lang="pt-PT" smtClean="0"/>
              <a:t>09/12/2024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32601-88EA-4257-8497-9DC6BAB1C045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84330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1721D8-7537-4217-957A-78F7EF9BAA1D}" type="datetimeFigureOut">
              <a:rPr lang="pt-PT" smtClean="0"/>
              <a:t>09/12/2024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32601-88EA-4257-8497-9DC6BAB1C045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298403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1721D8-7537-4217-957A-78F7EF9BAA1D}" type="datetimeFigureOut">
              <a:rPr lang="pt-PT" smtClean="0"/>
              <a:t>09/12/2024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32601-88EA-4257-8497-9DC6BAB1C045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720785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1721D8-7537-4217-957A-78F7EF9BAA1D}" type="datetimeFigureOut">
              <a:rPr lang="pt-PT" smtClean="0"/>
              <a:t>09/12/2024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32601-88EA-4257-8497-9DC6BAB1C045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2449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1721D8-7537-4217-957A-78F7EF9BAA1D}" type="datetimeFigureOut">
              <a:rPr lang="pt-PT" smtClean="0"/>
              <a:t>09/12/2024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32601-88EA-4257-8497-9DC6BAB1C045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219507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1721D8-7537-4217-957A-78F7EF9BAA1D}" type="datetimeFigureOut">
              <a:rPr lang="pt-PT" smtClean="0"/>
              <a:t>09/12/2024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32601-88EA-4257-8497-9DC6BAB1C045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078431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1721D8-7537-4217-957A-78F7EF9BAA1D}" type="datetimeFigureOut">
              <a:rPr lang="pt-PT" smtClean="0"/>
              <a:t>09/12/2024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32601-88EA-4257-8497-9DC6BAB1C045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543975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1721D8-7537-4217-957A-78F7EF9BAA1D}" type="datetimeFigureOut">
              <a:rPr lang="pt-PT" smtClean="0"/>
              <a:t>09/12/2024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32601-88EA-4257-8497-9DC6BAB1C045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543265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1721D8-7537-4217-957A-78F7EF9BAA1D}" type="datetimeFigureOut">
              <a:rPr lang="pt-PT" smtClean="0"/>
              <a:t>09/12/2024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32601-88EA-4257-8497-9DC6BAB1C045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888249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1721D8-7537-4217-957A-78F7EF9BAA1D}" type="datetimeFigureOut">
              <a:rPr lang="pt-PT" smtClean="0"/>
              <a:t>09/12/2024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32601-88EA-4257-8497-9DC6BAB1C045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30677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1721D8-7537-4217-957A-78F7EF9BAA1D}" type="datetimeFigureOut">
              <a:rPr lang="pt-PT" smtClean="0"/>
              <a:t>09/12/2024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F32601-88EA-4257-8497-9DC6BAB1C045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955705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1721D8-7537-4217-957A-78F7EF9BAA1D}" type="datetimeFigureOut">
              <a:rPr lang="pt-PT" smtClean="0"/>
              <a:t>09/12/2024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F32601-88EA-4257-8497-9DC6BAB1C045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3749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BB1B2ACC-6629-4ED0-A670-0F6414052496}"/>
              </a:ext>
            </a:extLst>
          </p:cNvPr>
          <p:cNvSpPr txBox="1"/>
          <p:nvPr/>
        </p:nvSpPr>
        <p:spPr>
          <a:xfrm>
            <a:off x="500158" y="575318"/>
            <a:ext cx="56466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pt-PT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pt-P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pt-P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pt-P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pt-P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eld</a:t>
            </a:r>
            <a:r>
              <a:rPr lang="pt-P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lection</a:t>
            </a:r>
            <a:r>
              <a:rPr lang="pt-P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tes in São Tomé </a:t>
            </a:r>
            <a:r>
              <a:rPr lang="pt-P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land</a:t>
            </a:r>
            <a:r>
              <a:rPr lang="pt-P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</a:t>
            </a:r>
            <a:r>
              <a:rPr lang="pt-P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pt-P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íncipe </a:t>
            </a:r>
            <a:r>
              <a:rPr lang="pt-P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land</a:t>
            </a:r>
            <a:r>
              <a:rPr lang="pt-P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6FAD19BF-B296-B850-E431-1B2ED70AAB30}"/>
              </a:ext>
            </a:extLst>
          </p:cNvPr>
          <p:cNvGrpSpPr/>
          <p:nvPr/>
        </p:nvGrpSpPr>
        <p:grpSpPr>
          <a:xfrm>
            <a:off x="132080" y="1026516"/>
            <a:ext cx="6725920" cy="4848993"/>
            <a:chOff x="132080" y="1026516"/>
            <a:chExt cx="6725920" cy="484899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7F5895E-2662-1443-1420-97530ECAA6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07" r="31386"/>
            <a:stretch/>
          </p:blipFill>
          <p:spPr>
            <a:xfrm>
              <a:off x="3694033" y="1246925"/>
              <a:ext cx="3163967" cy="419488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10599085-1D41-2C17-BD73-FBE6D7E7F4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592" r="21333"/>
            <a:stretch/>
          </p:blipFill>
          <p:spPr>
            <a:xfrm>
              <a:off x="132080" y="1026516"/>
              <a:ext cx="3708400" cy="4848993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2444BF6-81D5-6B9C-F716-FBB4A0C29167}"/>
                </a:ext>
              </a:extLst>
            </p:cNvPr>
            <p:cNvSpPr txBox="1"/>
            <p:nvPr/>
          </p:nvSpPr>
          <p:spPr>
            <a:xfrm>
              <a:off x="132080" y="1693162"/>
              <a:ext cx="368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dirty="0"/>
                <a:t>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0EC826F-88B6-4A98-E949-3385B40EF0EB}"/>
                </a:ext>
              </a:extLst>
            </p:cNvPr>
            <p:cNvSpPr txBox="1"/>
            <p:nvPr/>
          </p:nvSpPr>
          <p:spPr>
            <a:xfrm>
              <a:off x="3749040" y="1693162"/>
              <a:ext cx="368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695279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Imagem 18">
            <a:extLst>
              <a:ext uri="{FF2B5EF4-FFF2-40B4-BE49-F238E27FC236}">
                <a16:creationId xmlns:a16="http://schemas.microsoft.com/office/drawing/2014/main" id="{A9BEE99D-C82D-F0CD-DB25-AC40A532F1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3683" y="1116227"/>
            <a:ext cx="4748220" cy="1769659"/>
          </a:xfrm>
          <a:prstGeom prst="rect">
            <a:avLst/>
          </a:prstGeom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A044ECA1-D1F5-479E-8525-07F6079291E0}"/>
              </a:ext>
            </a:extLst>
          </p:cNvPr>
          <p:cNvSpPr txBox="1"/>
          <p:nvPr/>
        </p:nvSpPr>
        <p:spPr>
          <a:xfrm>
            <a:off x="571817" y="483526"/>
            <a:ext cx="57231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poral variation of insecticide resistance and knockdown resistance mutations in São Tomé and Príncipe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CaixaDeTexto 5">
            <a:extLst>
              <a:ext uri="{FF2B5EF4-FFF2-40B4-BE49-F238E27FC236}">
                <a16:creationId xmlns:a16="http://schemas.microsoft.com/office/drawing/2014/main" id="{B1D71DC7-0D4F-4343-AC97-520F41DAA2C2}"/>
              </a:ext>
            </a:extLst>
          </p:cNvPr>
          <p:cNvSpPr txBox="1"/>
          <p:nvPr/>
        </p:nvSpPr>
        <p:spPr>
          <a:xfrm>
            <a:off x="732771" y="1117601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A</a:t>
            </a:r>
          </a:p>
        </p:txBody>
      </p:sp>
      <p:pic>
        <p:nvPicPr>
          <p:cNvPr id="7" name="Imagem 6">
            <a:extLst>
              <a:ext uri="{FF2B5EF4-FFF2-40B4-BE49-F238E27FC236}">
                <a16:creationId xmlns:a16="http://schemas.microsoft.com/office/drawing/2014/main" id="{7EF80D85-2FF7-48F5-90F9-4F575307B5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8882" y="2835437"/>
            <a:ext cx="934598" cy="789501"/>
          </a:xfrm>
          <a:prstGeom prst="rect">
            <a:avLst/>
          </a:prstGeom>
        </p:spPr>
      </p:pic>
      <p:pic>
        <p:nvPicPr>
          <p:cNvPr id="8" name="Imagem 7">
            <a:extLst>
              <a:ext uri="{FF2B5EF4-FFF2-40B4-BE49-F238E27FC236}">
                <a16:creationId xmlns:a16="http://schemas.microsoft.com/office/drawing/2014/main" id="{85EDCFB3-B392-4E97-B645-1E18CF5724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14313" y="2835437"/>
            <a:ext cx="934598" cy="789501"/>
          </a:xfrm>
          <a:prstGeom prst="rect">
            <a:avLst/>
          </a:prstGeom>
        </p:spPr>
      </p:pic>
      <p:pic>
        <p:nvPicPr>
          <p:cNvPr id="9" name="Imagem 8">
            <a:extLst>
              <a:ext uri="{FF2B5EF4-FFF2-40B4-BE49-F238E27FC236}">
                <a16:creationId xmlns:a16="http://schemas.microsoft.com/office/drawing/2014/main" id="{71503B98-25B2-4B1A-BBCC-3C0065AA318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19744" y="2835437"/>
            <a:ext cx="934598" cy="789501"/>
          </a:xfrm>
          <a:prstGeom prst="rect">
            <a:avLst/>
          </a:prstGeom>
        </p:spPr>
      </p:pic>
      <p:pic>
        <p:nvPicPr>
          <p:cNvPr id="10" name="Imagem 9">
            <a:extLst>
              <a:ext uri="{FF2B5EF4-FFF2-40B4-BE49-F238E27FC236}">
                <a16:creationId xmlns:a16="http://schemas.microsoft.com/office/drawing/2014/main" id="{C0481BA7-E618-4106-A267-BA6C02CB88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25174" y="2835437"/>
            <a:ext cx="934598" cy="789501"/>
          </a:xfrm>
          <a:prstGeom prst="rect">
            <a:avLst/>
          </a:prstGeom>
        </p:spPr>
      </p:pic>
      <p:sp>
        <p:nvSpPr>
          <p:cNvPr id="11" name="CaixaDeTexto 10">
            <a:extLst>
              <a:ext uri="{FF2B5EF4-FFF2-40B4-BE49-F238E27FC236}">
                <a16:creationId xmlns:a16="http://schemas.microsoft.com/office/drawing/2014/main" id="{43AC7741-3017-4B0A-BD60-8D6E99026800}"/>
              </a:ext>
            </a:extLst>
          </p:cNvPr>
          <p:cNvSpPr txBox="1"/>
          <p:nvPr/>
        </p:nvSpPr>
        <p:spPr>
          <a:xfrm>
            <a:off x="732771" y="2835437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B</a:t>
            </a: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505B29F2-9A84-4C3D-BC61-367D54760419}"/>
              </a:ext>
            </a:extLst>
          </p:cNvPr>
          <p:cNvSpPr txBox="1"/>
          <p:nvPr/>
        </p:nvSpPr>
        <p:spPr>
          <a:xfrm>
            <a:off x="1644844" y="3529865"/>
            <a:ext cx="4635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03)</a:t>
            </a:r>
          </a:p>
        </p:txBody>
      </p:sp>
      <p:sp>
        <p:nvSpPr>
          <p:cNvPr id="13" name="CaixaDeTexto 12">
            <a:extLst>
              <a:ext uri="{FF2B5EF4-FFF2-40B4-BE49-F238E27FC236}">
                <a16:creationId xmlns:a16="http://schemas.microsoft.com/office/drawing/2014/main" id="{496EFEC2-5C94-4DFD-AA6A-101AB5D7D8AA}"/>
              </a:ext>
            </a:extLst>
          </p:cNvPr>
          <p:cNvSpPr txBox="1"/>
          <p:nvPr/>
        </p:nvSpPr>
        <p:spPr>
          <a:xfrm>
            <a:off x="2750122" y="3529865"/>
            <a:ext cx="4635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00)</a:t>
            </a:r>
          </a:p>
        </p:txBody>
      </p:sp>
      <p:sp>
        <p:nvSpPr>
          <p:cNvPr id="14" name="CaixaDeTexto 13">
            <a:extLst>
              <a:ext uri="{FF2B5EF4-FFF2-40B4-BE49-F238E27FC236}">
                <a16:creationId xmlns:a16="http://schemas.microsoft.com/office/drawing/2014/main" id="{19C16DB5-1BC1-4575-B008-0EDC073F8A82}"/>
              </a:ext>
            </a:extLst>
          </p:cNvPr>
          <p:cNvSpPr txBox="1"/>
          <p:nvPr/>
        </p:nvSpPr>
        <p:spPr>
          <a:xfrm>
            <a:off x="3855400" y="3529865"/>
            <a:ext cx="4635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45)</a:t>
            </a:r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165D73FB-C7C4-44C8-852F-7D5833FE2358}"/>
              </a:ext>
            </a:extLst>
          </p:cNvPr>
          <p:cNvSpPr txBox="1"/>
          <p:nvPr/>
        </p:nvSpPr>
        <p:spPr>
          <a:xfrm>
            <a:off x="4960679" y="3529865"/>
            <a:ext cx="4635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70)</a:t>
            </a:r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14F6914D-92DD-4E40-9438-6CBBD4190066}"/>
              </a:ext>
            </a:extLst>
          </p:cNvPr>
          <p:cNvSpPr txBox="1"/>
          <p:nvPr/>
        </p:nvSpPr>
        <p:spPr>
          <a:xfrm>
            <a:off x="211665" y="3914636"/>
            <a:ext cx="64346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 graphs display mortality rates 24 hours after exposure to the diagnostic dose of permethrin (orange) and DDT (blue). Y-axis: percent mortality, X-axis: year of the tests. Error bars indicate 95% confidence intervals. Dashed lines indicate 98% and 90% thresholds for susceptibility and resistance, respectively. Pie charts refer to the relative frequency of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r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eles for each year surveyed. White: </a:t>
            </a:r>
            <a:r>
              <a:rPr lang="en-US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s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TA); black: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r-w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TTT). Sample sizes are in parenthesis</a:t>
            </a:r>
          </a:p>
        </p:txBody>
      </p:sp>
      <p:grpSp>
        <p:nvGrpSpPr>
          <p:cNvPr id="2" name="Agrupar 1">
            <a:extLst>
              <a:ext uri="{FF2B5EF4-FFF2-40B4-BE49-F238E27FC236}">
                <a16:creationId xmlns:a16="http://schemas.microsoft.com/office/drawing/2014/main" id="{75604D1E-9EF8-9746-14DD-99C0B3A45BC4}"/>
              </a:ext>
            </a:extLst>
          </p:cNvPr>
          <p:cNvGrpSpPr/>
          <p:nvPr/>
        </p:nvGrpSpPr>
        <p:grpSpPr>
          <a:xfrm>
            <a:off x="1353228" y="1231101"/>
            <a:ext cx="4306544" cy="111695"/>
            <a:chOff x="1214810" y="1164890"/>
            <a:chExt cx="2429933" cy="205173"/>
          </a:xfrm>
        </p:grpSpPr>
        <p:cxnSp>
          <p:nvCxnSpPr>
            <p:cNvPr id="3" name="Conexão reta 2">
              <a:extLst>
                <a:ext uri="{FF2B5EF4-FFF2-40B4-BE49-F238E27FC236}">
                  <a16:creationId xmlns:a16="http://schemas.microsoft.com/office/drawing/2014/main" id="{9C66A35E-34D5-89F1-905E-F7DFDAA77CBF}"/>
                </a:ext>
              </a:extLst>
            </p:cNvPr>
            <p:cNvCxnSpPr>
              <a:cxnSpLocks/>
            </p:cNvCxnSpPr>
            <p:nvPr/>
          </p:nvCxnSpPr>
          <p:spPr>
            <a:xfrm>
              <a:off x="1214810" y="1164890"/>
              <a:ext cx="2429933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" name="Conexão reta 4">
              <a:extLst>
                <a:ext uri="{FF2B5EF4-FFF2-40B4-BE49-F238E27FC236}">
                  <a16:creationId xmlns:a16="http://schemas.microsoft.com/office/drawing/2014/main" id="{99E3E76B-5F10-5858-2C86-A30402295EE3}"/>
                </a:ext>
              </a:extLst>
            </p:cNvPr>
            <p:cNvCxnSpPr>
              <a:cxnSpLocks/>
            </p:cNvCxnSpPr>
            <p:nvPr/>
          </p:nvCxnSpPr>
          <p:spPr>
            <a:xfrm>
              <a:off x="1214810" y="1370063"/>
              <a:ext cx="2429933" cy="0"/>
            </a:xfrm>
            <a:prstGeom prst="line">
              <a:avLst/>
            </a:prstGeom>
            <a:ln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4244167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dk1"/>
        </a:lnRef>
        <a:fillRef idx="0">
          <a:schemeClr val="dk1"/>
        </a:fillRef>
        <a:effectRef idx="0">
          <a:schemeClr val="dk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1</TotalTime>
  <Words>149</Words>
  <Application>Microsoft Office PowerPoint</Application>
  <PresentationFormat>Papel A4 (210x297 mm)</PresentationFormat>
  <Paragraphs>11</Paragraphs>
  <Slides>2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o Office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João Pinto</dc:creator>
  <cp:lastModifiedBy>João Pinto</cp:lastModifiedBy>
  <cp:revision>36</cp:revision>
  <cp:lastPrinted>2024-08-14T14:38:14Z</cp:lastPrinted>
  <dcterms:created xsi:type="dcterms:W3CDTF">2024-05-08T18:11:17Z</dcterms:created>
  <dcterms:modified xsi:type="dcterms:W3CDTF">2024-12-09T17:01:55Z</dcterms:modified>
</cp:coreProperties>
</file>